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5" r:id="rId2"/>
    <p:sldId id="264" r:id="rId3"/>
    <p:sldId id="274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36"/>
    <p:restoredTop sz="95701"/>
  </p:normalViewPr>
  <p:slideViewPr>
    <p:cSldViewPr snapToGrid="0" snapToObjects="1">
      <p:cViewPr varScale="1">
        <p:scale>
          <a:sx n="114" d="100"/>
          <a:sy n="114" d="100"/>
        </p:scale>
        <p:origin x="43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C1C2B9-4F9F-6D47-BA85-135FF34F4D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26393CC-5A46-C446-9559-45020C9179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740C8B0-87BD-E444-A0F7-23B5A5EB7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EB35E-2E47-934D-9E81-2CBF6B5C8C4D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06FDCD-0386-A141-A79C-F065E73835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6119228-4600-EC49-A84E-13D53D266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0CDE1-424C-0049-8C5E-8D8AC5E88D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6793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AE2CE7-B722-0849-B61A-D35B65EAB9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531697A-43B1-4B46-B188-BA32D79AC9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CE7035E-CD76-CE4C-ABD6-2506F25CDB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EB35E-2E47-934D-9E81-2CBF6B5C8C4D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D41A534-5BCF-6E4A-AA38-D876892B3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EE1F1D-02C8-9341-86EB-3F83F3FDE2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0CDE1-424C-0049-8C5E-8D8AC5E88D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5935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F57AB32-0D16-0E48-84C8-FF036F479C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9819CC5-6245-9346-8602-55DD2D0D55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4111C81-4C22-D048-BFEF-40A8F510B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EB35E-2E47-934D-9E81-2CBF6B5C8C4D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BCAAFE-D14B-DF4C-8C1F-0A2F9B07FA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06EF344-6123-694B-8BEA-8FD14847F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0CDE1-424C-0049-8C5E-8D8AC5E88D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71924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EAB496-3215-934C-91DB-6290D8DF48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F408BA-FDAD-3247-92B5-AC4E5D2264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758AFC-CF7B-AA47-B847-58CD36FD6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EB35E-2E47-934D-9E81-2CBF6B5C8C4D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D2E308-5360-B741-9322-DFDA86914F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E477887-439E-9D47-A673-6F4D840F87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0CDE1-424C-0049-8C5E-8D8AC5E88D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1120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BF4118-874B-B64A-849E-6A27D5C8FA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B826BFB-C70B-AF44-B020-DB9AFD204C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07CCC3-6540-D245-B258-B8C74D0DE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EB35E-2E47-934D-9E81-2CBF6B5C8C4D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62FCFC5-1EB1-9E48-800B-004FCD787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C721A5-7C8E-724E-96DB-AA675B329E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0CDE1-424C-0049-8C5E-8D8AC5E88D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9044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A0847F-87D8-BA41-9B91-CA3C72E94A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5805A6E-6C33-C24A-8F03-347BE42ED7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117B0DB-F438-1A4A-946F-BF31A85793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F44DD57-53FF-454C-9DE0-A932EBD16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EB35E-2E47-934D-9E81-2CBF6B5C8C4D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4666B04-D2DE-1549-AA00-DFA35FDB6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7BEA5FB-7ABD-5848-BEF8-0CCE65E59D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0CDE1-424C-0049-8C5E-8D8AC5E88D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5180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4658DB-AE05-8042-B9EE-40C0FD328E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0AE028D-5B65-4749-828A-3C5ED5E143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00A98E6-C1D2-714B-9B47-CFE3778BD7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DF7404B-9F86-7C46-AA92-BB4828215D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9D0F10B-13E0-C141-836B-76567E24B2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E0BBA9F-AF28-C74A-84A2-D550B213B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EB35E-2E47-934D-9E81-2CBF6B5C8C4D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087FA72-220E-8A45-853E-77883137B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02D4C69-F6FE-9C41-8BF3-0287249DE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0CDE1-424C-0049-8C5E-8D8AC5E88D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0522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8867CF-3527-E849-AC53-DF3A735347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95FF73E-C0AE-B54F-9EAD-44D17B7C8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EB35E-2E47-934D-9E81-2CBF6B5C8C4D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F62984D-2383-E147-9F1A-BF7A406A6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912AA36-4067-A94E-936C-9391740B1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0CDE1-424C-0049-8C5E-8D8AC5E88D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3564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B0C5DC3-3799-DC45-914C-D24C8613B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EB35E-2E47-934D-9E81-2CBF6B5C8C4D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05B08D8-C601-A34B-803C-44FA517707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F507CBA-A7D0-DA4E-9A9B-1D178CB4D4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0CDE1-424C-0049-8C5E-8D8AC5E88D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6503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55CE9A-097E-C644-819E-907AED9A84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F8521D2-254F-6344-996C-10F82E0188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ADEF62E-19E9-2C45-8292-58AF061DF3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CC40F4C-3C2D-974D-9599-9ADD4032D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EB35E-2E47-934D-9E81-2CBF6B5C8C4D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6420E0F-A8BC-324B-A399-16924E6AE3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0A02E60-ED40-F344-97BC-8ABB39B19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0CDE1-424C-0049-8C5E-8D8AC5E88D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7748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02E3F70-9818-A846-A4D8-BCE03D42E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E0960CC-A96F-EC4F-B512-C66E6C6ABD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AE07662-0ABD-1F46-AD47-72F298F570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91D2C8D-8466-954B-84DE-C38336DDB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EB35E-2E47-934D-9E81-2CBF6B5C8C4D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63D9F32-BB9B-5F4C-9A42-4E3C57B088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FF7A4F6-7067-B843-9849-639684B314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0CDE1-424C-0049-8C5E-8D8AC5E88D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3827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AB59E75-C0F1-9F43-B5E5-E2FAFEAE07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D789E33-410F-4D4A-9EF9-92657BA686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957454F-0E37-3E48-920B-D205805650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AEB35E-2E47-934D-9E81-2CBF6B5C8C4D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47393AA-744E-C14E-87C1-07013C2296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942F86-9992-8E4C-85B4-6D5A7A0E7C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0CDE1-424C-0049-8C5E-8D8AC5E88D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4238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4EB0A1D-9752-48CB-8692-B55BF443C17C}"/>
              </a:ext>
            </a:extLst>
          </p:cNvPr>
          <p:cNvSpPr txBox="1"/>
          <p:nvPr/>
        </p:nvSpPr>
        <p:spPr>
          <a:xfrm>
            <a:off x="73413" y="0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6FB79A27-7413-4C0F-8477-13C619C82D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13399"/>
            <a:ext cx="12192000" cy="3831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07989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42ED441-C03A-4270-9EE1-DDE0B9A4957F}"/>
              </a:ext>
            </a:extLst>
          </p:cNvPr>
          <p:cNvSpPr txBox="1"/>
          <p:nvPr/>
        </p:nvSpPr>
        <p:spPr>
          <a:xfrm>
            <a:off x="3857501" y="920052"/>
            <a:ext cx="52370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tricular arrhythmias event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7650D151-76EF-C54C-B91D-C2579AE57028}"/>
              </a:ext>
            </a:extLst>
          </p:cNvPr>
          <p:cNvSpPr/>
          <p:nvPr/>
        </p:nvSpPr>
        <p:spPr>
          <a:xfrm>
            <a:off x="3251808" y="5277184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                51               43                35             31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74                57               43                35             28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27DF4705-A3C7-284F-875A-2D56A709DE1C}"/>
              </a:ext>
            </a:extLst>
          </p:cNvPr>
          <p:cNvSpPr/>
          <p:nvPr/>
        </p:nvSpPr>
        <p:spPr>
          <a:xfrm>
            <a:off x="572891" y="5000185"/>
            <a:ext cx="267891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isk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Non-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erpolypharmacy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Hyperpolypharmacy</a:t>
            </a: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D603D64C-7E34-BC4E-B679-1920C26009C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296927" y="1063348"/>
            <a:ext cx="9569450" cy="4351338"/>
            <a:chOff x="826" y="1150"/>
            <a:chExt cx="6028" cy="2741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36CEA5CC-2E1A-384D-A885-FC0D2E9BA0F8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826" y="1150"/>
              <a:ext cx="6028" cy="27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DFE2B111-1779-AB4C-B2AE-5E1F51E758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7" y="3399"/>
              <a:ext cx="135" cy="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UI Gothic" panose="020B0600070205080204" pitchFamily="50" charset="-128"/>
                  <a:ea typeface="MS UI Gothic" panose="020B0600070205080204" pitchFamily="50" charset="-128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6">
              <a:extLst>
                <a:ext uri="{FF2B5EF4-FFF2-40B4-BE49-F238E27FC236}">
                  <a16:creationId xmlns:a16="http://schemas.microsoft.com/office/drawing/2014/main" id="{93CFD0A0-C0B6-7B4D-B965-6BD748DF06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6" y="3399"/>
              <a:ext cx="281" cy="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UI Gothic" panose="020B0600070205080204" pitchFamily="50" charset="-128"/>
                  <a:ea typeface="MS UI Gothic" panose="020B0600070205080204" pitchFamily="50" charset="-128"/>
                </a:rPr>
                <a:t>5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7">
              <a:extLst>
                <a:ext uri="{FF2B5EF4-FFF2-40B4-BE49-F238E27FC236}">
                  <a16:creationId xmlns:a16="http://schemas.microsoft.com/office/drawing/2014/main" id="{4BABF92E-D4C4-0646-BEE8-A4F5F19A76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1" y="3399"/>
              <a:ext cx="354" cy="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UI Gothic" panose="020B0600070205080204" pitchFamily="50" charset="-128"/>
                  <a:ea typeface="MS UI Gothic" panose="020B0600070205080204" pitchFamily="50" charset="-128"/>
                </a:rPr>
                <a:t>10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8">
              <a:extLst>
                <a:ext uri="{FF2B5EF4-FFF2-40B4-BE49-F238E27FC236}">
                  <a16:creationId xmlns:a16="http://schemas.microsoft.com/office/drawing/2014/main" id="{16AAB6CE-8969-C74C-A290-1B614C14A9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5" y="3399"/>
              <a:ext cx="354" cy="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UI Gothic" panose="020B0600070205080204" pitchFamily="50" charset="-128"/>
                  <a:ea typeface="MS UI Gothic" panose="020B0600070205080204" pitchFamily="50" charset="-128"/>
                </a:rPr>
                <a:t>15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9">
              <a:extLst>
                <a:ext uri="{FF2B5EF4-FFF2-40B4-BE49-F238E27FC236}">
                  <a16:creationId xmlns:a16="http://schemas.microsoft.com/office/drawing/2014/main" id="{67C0A2D1-5F5D-5442-BF66-BB76B16FF0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9" y="3399"/>
              <a:ext cx="354" cy="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UI Gothic" panose="020B0600070205080204" pitchFamily="50" charset="-128"/>
                  <a:ea typeface="MS UI Gothic" panose="020B0600070205080204" pitchFamily="50" charset="-128"/>
                </a:rPr>
                <a:t>20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Freeform 10">
              <a:extLst>
                <a:ext uri="{FF2B5EF4-FFF2-40B4-BE49-F238E27FC236}">
                  <a16:creationId xmlns:a16="http://schemas.microsoft.com/office/drawing/2014/main" id="{CD913147-5135-5643-99CB-7ADA2456998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25" y="3291"/>
              <a:ext cx="2874" cy="81"/>
            </a:xfrm>
            <a:custGeom>
              <a:avLst/>
              <a:gdLst>
                <a:gd name="T0" fmla="*/ 0 w 2874"/>
                <a:gd name="T1" fmla="*/ 0 h 81"/>
                <a:gd name="T2" fmla="*/ 2874 w 2874"/>
                <a:gd name="T3" fmla="*/ 0 h 81"/>
                <a:gd name="T4" fmla="*/ 10 w 2874"/>
                <a:gd name="T5" fmla="*/ 0 h 81"/>
                <a:gd name="T6" fmla="*/ 10 w 2874"/>
                <a:gd name="T7" fmla="*/ 81 h 81"/>
                <a:gd name="T8" fmla="*/ 723 w 2874"/>
                <a:gd name="T9" fmla="*/ 0 h 81"/>
                <a:gd name="T10" fmla="*/ 723 w 2874"/>
                <a:gd name="T11" fmla="*/ 81 h 81"/>
                <a:gd name="T12" fmla="*/ 1437 w 2874"/>
                <a:gd name="T13" fmla="*/ 0 h 81"/>
                <a:gd name="T14" fmla="*/ 1437 w 2874"/>
                <a:gd name="T15" fmla="*/ 81 h 81"/>
                <a:gd name="T16" fmla="*/ 2151 w 2874"/>
                <a:gd name="T17" fmla="*/ 0 h 81"/>
                <a:gd name="T18" fmla="*/ 2151 w 2874"/>
                <a:gd name="T19" fmla="*/ 81 h 81"/>
                <a:gd name="T20" fmla="*/ 2864 w 2874"/>
                <a:gd name="T21" fmla="*/ 0 h 81"/>
                <a:gd name="T22" fmla="*/ 2864 w 2874"/>
                <a:gd name="T23" fmla="*/ 81 h 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874" h="81">
                  <a:moveTo>
                    <a:pt x="0" y="0"/>
                  </a:moveTo>
                  <a:lnTo>
                    <a:pt x="2874" y="0"/>
                  </a:lnTo>
                  <a:moveTo>
                    <a:pt x="10" y="0"/>
                  </a:moveTo>
                  <a:lnTo>
                    <a:pt x="10" y="81"/>
                  </a:lnTo>
                  <a:moveTo>
                    <a:pt x="723" y="0"/>
                  </a:moveTo>
                  <a:lnTo>
                    <a:pt x="723" y="81"/>
                  </a:lnTo>
                  <a:moveTo>
                    <a:pt x="1437" y="0"/>
                  </a:moveTo>
                  <a:lnTo>
                    <a:pt x="1437" y="81"/>
                  </a:lnTo>
                  <a:moveTo>
                    <a:pt x="2151" y="0"/>
                  </a:moveTo>
                  <a:lnTo>
                    <a:pt x="2151" y="81"/>
                  </a:lnTo>
                  <a:moveTo>
                    <a:pt x="2864" y="0"/>
                  </a:moveTo>
                  <a:lnTo>
                    <a:pt x="2864" y="81"/>
                  </a:lnTo>
                </a:path>
              </a:pathLst>
            </a:custGeom>
            <a:noFill/>
            <a:ln w="301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Rectangle 11">
              <a:extLst>
                <a:ext uri="{FF2B5EF4-FFF2-40B4-BE49-F238E27FC236}">
                  <a16:creationId xmlns:a16="http://schemas.microsoft.com/office/drawing/2014/main" id="{83DC4059-8CD4-5B4A-897D-43FC5F2A61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0" y="3220"/>
              <a:ext cx="135" cy="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UI Gothic" panose="020B0600070205080204" pitchFamily="50" charset="-128"/>
                  <a:ea typeface="MS UI Gothic" panose="020B0600070205080204" pitchFamily="50" charset="-128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2">
              <a:extLst>
                <a:ext uri="{FF2B5EF4-FFF2-40B4-BE49-F238E27FC236}">
                  <a16:creationId xmlns:a16="http://schemas.microsoft.com/office/drawing/2014/main" id="{52D18407-EAA9-8741-8986-5A37CAA9A3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4" y="2355"/>
              <a:ext cx="208" cy="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UI Gothic" panose="020B0600070205080204" pitchFamily="50" charset="-128"/>
                  <a:ea typeface="MS UI Gothic" panose="020B0600070205080204" pitchFamily="50" charset="-128"/>
                </a:rPr>
                <a:t>5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3">
              <a:extLst>
                <a:ext uri="{FF2B5EF4-FFF2-40B4-BE49-F238E27FC236}">
                  <a16:creationId xmlns:a16="http://schemas.microsoft.com/office/drawing/2014/main" id="{AAE8C6B3-3D33-2040-9133-429EEB0A84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0" y="1491"/>
              <a:ext cx="281" cy="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UI Gothic" panose="020B0600070205080204" pitchFamily="50" charset="-128"/>
                  <a:ea typeface="MS UI Gothic" panose="020B0600070205080204" pitchFamily="50" charset="-128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Freeform 14">
              <a:extLst>
                <a:ext uri="{FF2B5EF4-FFF2-40B4-BE49-F238E27FC236}">
                  <a16:creationId xmlns:a16="http://schemas.microsoft.com/office/drawing/2014/main" id="{2AD01A11-9CB1-5141-9761-1518B7EB875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454" y="1378"/>
              <a:ext cx="81" cy="1923"/>
            </a:xfrm>
            <a:custGeom>
              <a:avLst/>
              <a:gdLst>
                <a:gd name="T0" fmla="*/ 81 w 81"/>
                <a:gd name="T1" fmla="*/ 1923 h 1923"/>
                <a:gd name="T2" fmla="*/ 81 w 81"/>
                <a:gd name="T3" fmla="*/ 0 h 1923"/>
                <a:gd name="T4" fmla="*/ 81 w 81"/>
                <a:gd name="T5" fmla="*/ 1913 h 1923"/>
                <a:gd name="T6" fmla="*/ 0 w 81"/>
                <a:gd name="T7" fmla="*/ 1913 h 1923"/>
                <a:gd name="T8" fmla="*/ 81 w 81"/>
                <a:gd name="T9" fmla="*/ 1049 h 1923"/>
                <a:gd name="T10" fmla="*/ 0 w 81"/>
                <a:gd name="T11" fmla="*/ 1049 h 1923"/>
                <a:gd name="T12" fmla="*/ 81 w 81"/>
                <a:gd name="T13" fmla="*/ 184 h 1923"/>
                <a:gd name="T14" fmla="*/ 0 w 81"/>
                <a:gd name="T15" fmla="*/ 184 h 1923"/>
                <a:gd name="T16" fmla="*/ 81 w 81"/>
                <a:gd name="T17" fmla="*/ 1826 h 1923"/>
                <a:gd name="T18" fmla="*/ 36 w 81"/>
                <a:gd name="T19" fmla="*/ 1826 h 1923"/>
                <a:gd name="T20" fmla="*/ 81 w 81"/>
                <a:gd name="T21" fmla="*/ 1740 h 1923"/>
                <a:gd name="T22" fmla="*/ 36 w 81"/>
                <a:gd name="T23" fmla="*/ 1740 h 1923"/>
                <a:gd name="T24" fmla="*/ 81 w 81"/>
                <a:gd name="T25" fmla="*/ 1653 h 1923"/>
                <a:gd name="T26" fmla="*/ 36 w 81"/>
                <a:gd name="T27" fmla="*/ 1653 h 1923"/>
                <a:gd name="T28" fmla="*/ 81 w 81"/>
                <a:gd name="T29" fmla="*/ 1568 h 1923"/>
                <a:gd name="T30" fmla="*/ 36 w 81"/>
                <a:gd name="T31" fmla="*/ 1568 h 1923"/>
                <a:gd name="T32" fmla="*/ 81 w 81"/>
                <a:gd name="T33" fmla="*/ 1480 h 1923"/>
                <a:gd name="T34" fmla="*/ 36 w 81"/>
                <a:gd name="T35" fmla="*/ 1480 h 1923"/>
                <a:gd name="T36" fmla="*/ 81 w 81"/>
                <a:gd name="T37" fmla="*/ 1395 h 1923"/>
                <a:gd name="T38" fmla="*/ 36 w 81"/>
                <a:gd name="T39" fmla="*/ 1395 h 1923"/>
                <a:gd name="T40" fmla="*/ 81 w 81"/>
                <a:gd name="T41" fmla="*/ 1307 h 1923"/>
                <a:gd name="T42" fmla="*/ 36 w 81"/>
                <a:gd name="T43" fmla="*/ 1307 h 1923"/>
                <a:gd name="T44" fmla="*/ 81 w 81"/>
                <a:gd name="T45" fmla="*/ 1222 h 1923"/>
                <a:gd name="T46" fmla="*/ 36 w 81"/>
                <a:gd name="T47" fmla="*/ 1222 h 1923"/>
                <a:gd name="T48" fmla="*/ 81 w 81"/>
                <a:gd name="T49" fmla="*/ 1135 h 1923"/>
                <a:gd name="T50" fmla="*/ 36 w 81"/>
                <a:gd name="T51" fmla="*/ 1135 h 1923"/>
                <a:gd name="T52" fmla="*/ 81 w 81"/>
                <a:gd name="T53" fmla="*/ 962 h 1923"/>
                <a:gd name="T54" fmla="*/ 36 w 81"/>
                <a:gd name="T55" fmla="*/ 962 h 1923"/>
                <a:gd name="T56" fmla="*/ 81 w 81"/>
                <a:gd name="T57" fmla="*/ 876 h 1923"/>
                <a:gd name="T58" fmla="*/ 36 w 81"/>
                <a:gd name="T59" fmla="*/ 876 h 1923"/>
                <a:gd name="T60" fmla="*/ 81 w 81"/>
                <a:gd name="T61" fmla="*/ 789 h 1923"/>
                <a:gd name="T62" fmla="*/ 36 w 81"/>
                <a:gd name="T63" fmla="*/ 789 h 1923"/>
                <a:gd name="T64" fmla="*/ 81 w 81"/>
                <a:gd name="T65" fmla="*/ 703 h 1923"/>
                <a:gd name="T66" fmla="*/ 36 w 81"/>
                <a:gd name="T67" fmla="*/ 703 h 1923"/>
                <a:gd name="T68" fmla="*/ 81 w 81"/>
                <a:gd name="T69" fmla="*/ 616 h 1923"/>
                <a:gd name="T70" fmla="*/ 36 w 81"/>
                <a:gd name="T71" fmla="*/ 616 h 1923"/>
                <a:gd name="T72" fmla="*/ 81 w 81"/>
                <a:gd name="T73" fmla="*/ 530 h 1923"/>
                <a:gd name="T74" fmla="*/ 36 w 81"/>
                <a:gd name="T75" fmla="*/ 530 h 1923"/>
                <a:gd name="T76" fmla="*/ 81 w 81"/>
                <a:gd name="T77" fmla="*/ 443 h 1923"/>
                <a:gd name="T78" fmla="*/ 36 w 81"/>
                <a:gd name="T79" fmla="*/ 443 h 1923"/>
                <a:gd name="T80" fmla="*/ 81 w 81"/>
                <a:gd name="T81" fmla="*/ 357 h 1923"/>
                <a:gd name="T82" fmla="*/ 36 w 81"/>
                <a:gd name="T83" fmla="*/ 357 h 1923"/>
                <a:gd name="T84" fmla="*/ 81 w 81"/>
                <a:gd name="T85" fmla="*/ 270 h 1923"/>
                <a:gd name="T86" fmla="*/ 36 w 81"/>
                <a:gd name="T87" fmla="*/ 270 h 1923"/>
                <a:gd name="T88" fmla="*/ 81 w 81"/>
                <a:gd name="T89" fmla="*/ 97 h 1923"/>
                <a:gd name="T90" fmla="*/ 36 w 81"/>
                <a:gd name="T91" fmla="*/ 97 h 1923"/>
                <a:gd name="T92" fmla="*/ 81 w 81"/>
                <a:gd name="T93" fmla="*/ 12 h 1923"/>
                <a:gd name="T94" fmla="*/ 36 w 81"/>
                <a:gd name="T95" fmla="*/ 12 h 19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81" h="1923">
                  <a:moveTo>
                    <a:pt x="81" y="1923"/>
                  </a:moveTo>
                  <a:lnTo>
                    <a:pt x="81" y="0"/>
                  </a:lnTo>
                  <a:moveTo>
                    <a:pt x="81" y="1913"/>
                  </a:moveTo>
                  <a:lnTo>
                    <a:pt x="0" y="1913"/>
                  </a:lnTo>
                  <a:moveTo>
                    <a:pt x="81" y="1049"/>
                  </a:moveTo>
                  <a:lnTo>
                    <a:pt x="0" y="1049"/>
                  </a:lnTo>
                  <a:moveTo>
                    <a:pt x="81" y="184"/>
                  </a:moveTo>
                  <a:lnTo>
                    <a:pt x="0" y="184"/>
                  </a:lnTo>
                  <a:moveTo>
                    <a:pt x="81" y="1826"/>
                  </a:moveTo>
                  <a:lnTo>
                    <a:pt x="36" y="1826"/>
                  </a:lnTo>
                  <a:moveTo>
                    <a:pt x="81" y="1740"/>
                  </a:moveTo>
                  <a:lnTo>
                    <a:pt x="36" y="1740"/>
                  </a:lnTo>
                  <a:moveTo>
                    <a:pt x="81" y="1653"/>
                  </a:moveTo>
                  <a:lnTo>
                    <a:pt x="36" y="1653"/>
                  </a:lnTo>
                  <a:moveTo>
                    <a:pt x="81" y="1568"/>
                  </a:moveTo>
                  <a:lnTo>
                    <a:pt x="36" y="1568"/>
                  </a:lnTo>
                  <a:moveTo>
                    <a:pt x="81" y="1480"/>
                  </a:moveTo>
                  <a:lnTo>
                    <a:pt x="36" y="1480"/>
                  </a:lnTo>
                  <a:moveTo>
                    <a:pt x="81" y="1395"/>
                  </a:moveTo>
                  <a:lnTo>
                    <a:pt x="36" y="1395"/>
                  </a:lnTo>
                  <a:moveTo>
                    <a:pt x="81" y="1307"/>
                  </a:moveTo>
                  <a:lnTo>
                    <a:pt x="36" y="1307"/>
                  </a:lnTo>
                  <a:moveTo>
                    <a:pt x="81" y="1222"/>
                  </a:moveTo>
                  <a:lnTo>
                    <a:pt x="36" y="1222"/>
                  </a:lnTo>
                  <a:moveTo>
                    <a:pt x="81" y="1135"/>
                  </a:moveTo>
                  <a:lnTo>
                    <a:pt x="36" y="1135"/>
                  </a:lnTo>
                  <a:moveTo>
                    <a:pt x="81" y="962"/>
                  </a:moveTo>
                  <a:lnTo>
                    <a:pt x="36" y="962"/>
                  </a:lnTo>
                  <a:moveTo>
                    <a:pt x="81" y="876"/>
                  </a:moveTo>
                  <a:lnTo>
                    <a:pt x="36" y="876"/>
                  </a:lnTo>
                  <a:moveTo>
                    <a:pt x="81" y="789"/>
                  </a:moveTo>
                  <a:lnTo>
                    <a:pt x="36" y="789"/>
                  </a:lnTo>
                  <a:moveTo>
                    <a:pt x="81" y="703"/>
                  </a:moveTo>
                  <a:lnTo>
                    <a:pt x="36" y="703"/>
                  </a:lnTo>
                  <a:moveTo>
                    <a:pt x="81" y="616"/>
                  </a:moveTo>
                  <a:lnTo>
                    <a:pt x="36" y="616"/>
                  </a:lnTo>
                  <a:moveTo>
                    <a:pt x="81" y="530"/>
                  </a:moveTo>
                  <a:lnTo>
                    <a:pt x="36" y="530"/>
                  </a:lnTo>
                  <a:moveTo>
                    <a:pt x="81" y="443"/>
                  </a:moveTo>
                  <a:lnTo>
                    <a:pt x="36" y="443"/>
                  </a:lnTo>
                  <a:moveTo>
                    <a:pt x="81" y="357"/>
                  </a:moveTo>
                  <a:lnTo>
                    <a:pt x="36" y="357"/>
                  </a:lnTo>
                  <a:moveTo>
                    <a:pt x="81" y="270"/>
                  </a:moveTo>
                  <a:lnTo>
                    <a:pt x="36" y="270"/>
                  </a:lnTo>
                  <a:moveTo>
                    <a:pt x="81" y="97"/>
                  </a:moveTo>
                  <a:lnTo>
                    <a:pt x="36" y="97"/>
                  </a:lnTo>
                  <a:moveTo>
                    <a:pt x="81" y="12"/>
                  </a:moveTo>
                  <a:lnTo>
                    <a:pt x="36" y="12"/>
                  </a:lnTo>
                </a:path>
              </a:pathLst>
            </a:custGeom>
            <a:noFill/>
            <a:ln w="301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" name="Freeform 15">
              <a:extLst>
                <a:ext uri="{FF2B5EF4-FFF2-40B4-BE49-F238E27FC236}">
                  <a16:creationId xmlns:a16="http://schemas.microsoft.com/office/drawing/2014/main" id="{C36B4702-D46A-B74B-BA58-B897D2694F20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5" y="1562"/>
              <a:ext cx="2604" cy="386"/>
            </a:xfrm>
            <a:custGeom>
              <a:avLst/>
              <a:gdLst>
                <a:gd name="T0" fmla="*/ 0 w 2604"/>
                <a:gd name="T1" fmla="*/ 0 h 386"/>
                <a:gd name="T2" fmla="*/ 0 w 2604"/>
                <a:gd name="T3" fmla="*/ 0 h 386"/>
                <a:gd name="T4" fmla="*/ 3 w 2604"/>
                <a:gd name="T5" fmla="*/ 29 h 386"/>
                <a:gd name="T6" fmla="*/ 65 w 2604"/>
                <a:gd name="T7" fmla="*/ 29 h 386"/>
                <a:gd name="T8" fmla="*/ 65 w 2604"/>
                <a:gd name="T9" fmla="*/ 58 h 386"/>
                <a:gd name="T10" fmla="*/ 85 w 2604"/>
                <a:gd name="T11" fmla="*/ 86 h 386"/>
                <a:gd name="T12" fmla="*/ 214 w 2604"/>
                <a:gd name="T13" fmla="*/ 86 h 386"/>
                <a:gd name="T14" fmla="*/ 214 w 2604"/>
                <a:gd name="T15" fmla="*/ 86 h 386"/>
                <a:gd name="T16" fmla="*/ 242 w 2604"/>
                <a:gd name="T17" fmla="*/ 116 h 386"/>
                <a:gd name="T18" fmla="*/ 414 w 2604"/>
                <a:gd name="T19" fmla="*/ 116 h 386"/>
                <a:gd name="T20" fmla="*/ 414 w 2604"/>
                <a:gd name="T21" fmla="*/ 145 h 386"/>
                <a:gd name="T22" fmla="*/ 449 w 2604"/>
                <a:gd name="T23" fmla="*/ 175 h 386"/>
                <a:gd name="T24" fmla="*/ 623 w 2604"/>
                <a:gd name="T25" fmla="*/ 175 h 386"/>
                <a:gd name="T26" fmla="*/ 623 w 2604"/>
                <a:gd name="T27" fmla="*/ 175 h 386"/>
                <a:gd name="T28" fmla="*/ 650 w 2604"/>
                <a:gd name="T29" fmla="*/ 175 h 386"/>
                <a:gd name="T30" fmla="*/ 796 w 2604"/>
                <a:gd name="T31" fmla="*/ 175 h 386"/>
                <a:gd name="T32" fmla="*/ 796 w 2604"/>
                <a:gd name="T33" fmla="*/ 205 h 386"/>
                <a:gd name="T34" fmla="*/ 1110 w 2604"/>
                <a:gd name="T35" fmla="*/ 205 h 386"/>
                <a:gd name="T36" fmla="*/ 1113 w 2604"/>
                <a:gd name="T37" fmla="*/ 205 h 386"/>
                <a:gd name="T38" fmla="*/ 1113 w 2604"/>
                <a:gd name="T39" fmla="*/ 205 h 386"/>
                <a:gd name="T40" fmla="*/ 1200 w 2604"/>
                <a:gd name="T41" fmla="*/ 205 h 386"/>
                <a:gd name="T42" fmla="*/ 1215 w 2604"/>
                <a:gd name="T43" fmla="*/ 205 h 386"/>
                <a:gd name="T44" fmla="*/ 1215 w 2604"/>
                <a:gd name="T45" fmla="*/ 240 h 386"/>
                <a:gd name="T46" fmla="*/ 1224 w 2604"/>
                <a:gd name="T47" fmla="*/ 273 h 386"/>
                <a:gd name="T48" fmla="*/ 1422 w 2604"/>
                <a:gd name="T49" fmla="*/ 273 h 386"/>
                <a:gd name="T50" fmla="*/ 1422 w 2604"/>
                <a:gd name="T51" fmla="*/ 273 h 386"/>
                <a:gd name="T52" fmla="*/ 1509 w 2604"/>
                <a:gd name="T53" fmla="*/ 308 h 386"/>
                <a:gd name="T54" fmla="*/ 1622 w 2604"/>
                <a:gd name="T55" fmla="*/ 308 h 386"/>
                <a:gd name="T56" fmla="*/ 1622 w 2604"/>
                <a:gd name="T57" fmla="*/ 308 h 386"/>
                <a:gd name="T58" fmla="*/ 1703 w 2604"/>
                <a:gd name="T59" fmla="*/ 308 h 386"/>
                <a:gd name="T60" fmla="*/ 1789 w 2604"/>
                <a:gd name="T61" fmla="*/ 308 h 386"/>
                <a:gd name="T62" fmla="*/ 1789 w 2604"/>
                <a:gd name="T63" fmla="*/ 345 h 386"/>
                <a:gd name="T64" fmla="*/ 1822 w 2604"/>
                <a:gd name="T65" fmla="*/ 345 h 386"/>
                <a:gd name="T66" fmla="*/ 1868 w 2604"/>
                <a:gd name="T67" fmla="*/ 345 h 386"/>
                <a:gd name="T68" fmla="*/ 1869 w 2604"/>
                <a:gd name="T69" fmla="*/ 345 h 386"/>
                <a:gd name="T70" fmla="*/ 2066 w 2604"/>
                <a:gd name="T71" fmla="*/ 345 h 386"/>
                <a:gd name="T72" fmla="*/ 2298 w 2604"/>
                <a:gd name="T73" fmla="*/ 345 h 386"/>
                <a:gd name="T74" fmla="*/ 2298 w 2604"/>
                <a:gd name="T75" fmla="*/ 386 h 386"/>
                <a:gd name="T76" fmla="*/ 2385 w 2604"/>
                <a:gd name="T77" fmla="*/ 386 h 386"/>
                <a:gd name="T78" fmla="*/ 2542 w 2604"/>
                <a:gd name="T79" fmla="*/ 386 h 386"/>
                <a:gd name="T80" fmla="*/ 2542 w 2604"/>
                <a:gd name="T81" fmla="*/ 386 h 386"/>
                <a:gd name="T82" fmla="*/ 2604 w 2604"/>
                <a:gd name="T83" fmla="*/ 386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2604" h="386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3" y="0"/>
                  </a:lnTo>
                  <a:lnTo>
                    <a:pt x="3" y="29"/>
                  </a:lnTo>
                  <a:lnTo>
                    <a:pt x="3" y="29"/>
                  </a:lnTo>
                  <a:lnTo>
                    <a:pt x="65" y="29"/>
                  </a:lnTo>
                  <a:lnTo>
                    <a:pt x="65" y="58"/>
                  </a:lnTo>
                  <a:lnTo>
                    <a:pt x="65" y="58"/>
                  </a:lnTo>
                  <a:lnTo>
                    <a:pt x="85" y="58"/>
                  </a:lnTo>
                  <a:lnTo>
                    <a:pt x="85" y="86"/>
                  </a:lnTo>
                  <a:lnTo>
                    <a:pt x="85" y="86"/>
                  </a:lnTo>
                  <a:lnTo>
                    <a:pt x="214" y="86"/>
                  </a:lnTo>
                  <a:lnTo>
                    <a:pt x="214" y="86"/>
                  </a:lnTo>
                  <a:lnTo>
                    <a:pt x="214" y="86"/>
                  </a:lnTo>
                  <a:lnTo>
                    <a:pt x="242" y="86"/>
                  </a:lnTo>
                  <a:lnTo>
                    <a:pt x="242" y="116"/>
                  </a:lnTo>
                  <a:lnTo>
                    <a:pt x="242" y="116"/>
                  </a:lnTo>
                  <a:lnTo>
                    <a:pt x="414" y="116"/>
                  </a:lnTo>
                  <a:lnTo>
                    <a:pt x="414" y="145"/>
                  </a:lnTo>
                  <a:lnTo>
                    <a:pt x="414" y="145"/>
                  </a:lnTo>
                  <a:lnTo>
                    <a:pt x="449" y="145"/>
                  </a:lnTo>
                  <a:lnTo>
                    <a:pt x="449" y="175"/>
                  </a:lnTo>
                  <a:lnTo>
                    <a:pt x="449" y="175"/>
                  </a:lnTo>
                  <a:lnTo>
                    <a:pt x="623" y="175"/>
                  </a:lnTo>
                  <a:lnTo>
                    <a:pt x="623" y="175"/>
                  </a:lnTo>
                  <a:lnTo>
                    <a:pt x="623" y="175"/>
                  </a:lnTo>
                  <a:lnTo>
                    <a:pt x="650" y="175"/>
                  </a:lnTo>
                  <a:lnTo>
                    <a:pt x="650" y="175"/>
                  </a:lnTo>
                  <a:lnTo>
                    <a:pt x="652" y="175"/>
                  </a:lnTo>
                  <a:lnTo>
                    <a:pt x="796" y="175"/>
                  </a:lnTo>
                  <a:lnTo>
                    <a:pt x="796" y="205"/>
                  </a:lnTo>
                  <a:lnTo>
                    <a:pt x="796" y="205"/>
                  </a:lnTo>
                  <a:lnTo>
                    <a:pt x="1110" y="205"/>
                  </a:lnTo>
                  <a:lnTo>
                    <a:pt x="1110" y="205"/>
                  </a:lnTo>
                  <a:lnTo>
                    <a:pt x="1110" y="205"/>
                  </a:lnTo>
                  <a:lnTo>
                    <a:pt x="1113" y="205"/>
                  </a:lnTo>
                  <a:lnTo>
                    <a:pt x="1113" y="205"/>
                  </a:lnTo>
                  <a:lnTo>
                    <a:pt x="1113" y="205"/>
                  </a:lnTo>
                  <a:lnTo>
                    <a:pt x="1200" y="205"/>
                  </a:lnTo>
                  <a:lnTo>
                    <a:pt x="1200" y="205"/>
                  </a:lnTo>
                  <a:lnTo>
                    <a:pt x="1207" y="205"/>
                  </a:lnTo>
                  <a:lnTo>
                    <a:pt x="1215" y="205"/>
                  </a:lnTo>
                  <a:lnTo>
                    <a:pt x="1215" y="240"/>
                  </a:lnTo>
                  <a:lnTo>
                    <a:pt x="1215" y="240"/>
                  </a:lnTo>
                  <a:lnTo>
                    <a:pt x="1224" y="240"/>
                  </a:lnTo>
                  <a:lnTo>
                    <a:pt x="1224" y="273"/>
                  </a:lnTo>
                  <a:lnTo>
                    <a:pt x="1224" y="273"/>
                  </a:lnTo>
                  <a:lnTo>
                    <a:pt x="1422" y="273"/>
                  </a:lnTo>
                  <a:lnTo>
                    <a:pt x="1422" y="273"/>
                  </a:lnTo>
                  <a:lnTo>
                    <a:pt x="1422" y="273"/>
                  </a:lnTo>
                  <a:lnTo>
                    <a:pt x="1509" y="273"/>
                  </a:lnTo>
                  <a:lnTo>
                    <a:pt x="1509" y="308"/>
                  </a:lnTo>
                  <a:lnTo>
                    <a:pt x="1509" y="308"/>
                  </a:lnTo>
                  <a:lnTo>
                    <a:pt x="1622" y="308"/>
                  </a:lnTo>
                  <a:lnTo>
                    <a:pt x="1622" y="308"/>
                  </a:lnTo>
                  <a:lnTo>
                    <a:pt x="1622" y="308"/>
                  </a:lnTo>
                  <a:lnTo>
                    <a:pt x="1703" y="308"/>
                  </a:lnTo>
                  <a:lnTo>
                    <a:pt x="1703" y="308"/>
                  </a:lnTo>
                  <a:lnTo>
                    <a:pt x="1703" y="308"/>
                  </a:lnTo>
                  <a:lnTo>
                    <a:pt x="1789" y="308"/>
                  </a:lnTo>
                  <a:lnTo>
                    <a:pt x="1789" y="345"/>
                  </a:lnTo>
                  <a:lnTo>
                    <a:pt x="1789" y="345"/>
                  </a:lnTo>
                  <a:lnTo>
                    <a:pt x="1822" y="345"/>
                  </a:lnTo>
                  <a:lnTo>
                    <a:pt x="1822" y="345"/>
                  </a:lnTo>
                  <a:lnTo>
                    <a:pt x="1822" y="345"/>
                  </a:lnTo>
                  <a:lnTo>
                    <a:pt x="1868" y="345"/>
                  </a:lnTo>
                  <a:lnTo>
                    <a:pt x="1868" y="345"/>
                  </a:lnTo>
                  <a:lnTo>
                    <a:pt x="1869" y="345"/>
                  </a:lnTo>
                  <a:lnTo>
                    <a:pt x="2066" y="345"/>
                  </a:lnTo>
                  <a:lnTo>
                    <a:pt x="2066" y="345"/>
                  </a:lnTo>
                  <a:lnTo>
                    <a:pt x="2066" y="345"/>
                  </a:lnTo>
                  <a:lnTo>
                    <a:pt x="2298" y="345"/>
                  </a:lnTo>
                  <a:lnTo>
                    <a:pt x="2298" y="386"/>
                  </a:lnTo>
                  <a:lnTo>
                    <a:pt x="2298" y="386"/>
                  </a:lnTo>
                  <a:lnTo>
                    <a:pt x="2385" y="386"/>
                  </a:lnTo>
                  <a:lnTo>
                    <a:pt x="2385" y="386"/>
                  </a:lnTo>
                  <a:lnTo>
                    <a:pt x="2385" y="386"/>
                  </a:lnTo>
                  <a:lnTo>
                    <a:pt x="2542" y="386"/>
                  </a:lnTo>
                  <a:lnTo>
                    <a:pt x="2542" y="386"/>
                  </a:lnTo>
                  <a:lnTo>
                    <a:pt x="2542" y="386"/>
                  </a:lnTo>
                  <a:lnTo>
                    <a:pt x="2604" y="386"/>
                  </a:lnTo>
                  <a:lnTo>
                    <a:pt x="2604" y="386"/>
                  </a:lnTo>
                </a:path>
              </a:pathLst>
            </a:custGeom>
            <a:noFill/>
            <a:ln w="46038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" name="Freeform 16">
              <a:extLst>
                <a:ext uri="{FF2B5EF4-FFF2-40B4-BE49-F238E27FC236}">
                  <a16:creationId xmlns:a16="http://schemas.microsoft.com/office/drawing/2014/main" id="{BCB8D763-E614-7042-8F06-73BC39C08710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5" y="1562"/>
              <a:ext cx="2604" cy="500"/>
            </a:xfrm>
            <a:custGeom>
              <a:avLst/>
              <a:gdLst>
                <a:gd name="T0" fmla="*/ 0 w 2604"/>
                <a:gd name="T1" fmla="*/ 0 h 500"/>
                <a:gd name="T2" fmla="*/ 1 w 2604"/>
                <a:gd name="T3" fmla="*/ 23 h 500"/>
                <a:gd name="T4" fmla="*/ 33 w 2604"/>
                <a:gd name="T5" fmla="*/ 23 h 500"/>
                <a:gd name="T6" fmla="*/ 57 w 2604"/>
                <a:gd name="T7" fmla="*/ 46 h 500"/>
                <a:gd name="T8" fmla="*/ 81 w 2604"/>
                <a:gd name="T9" fmla="*/ 70 h 500"/>
                <a:gd name="T10" fmla="*/ 82 w 2604"/>
                <a:gd name="T11" fmla="*/ 94 h 500"/>
                <a:gd name="T12" fmla="*/ 114 w 2604"/>
                <a:gd name="T13" fmla="*/ 118 h 500"/>
                <a:gd name="T14" fmla="*/ 144 w 2604"/>
                <a:gd name="T15" fmla="*/ 142 h 500"/>
                <a:gd name="T16" fmla="*/ 168 w 2604"/>
                <a:gd name="T17" fmla="*/ 142 h 500"/>
                <a:gd name="T18" fmla="*/ 182 w 2604"/>
                <a:gd name="T19" fmla="*/ 165 h 500"/>
                <a:gd name="T20" fmla="*/ 208 w 2604"/>
                <a:gd name="T21" fmla="*/ 189 h 500"/>
                <a:gd name="T22" fmla="*/ 342 w 2604"/>
                <a:gd name="T23" fmla="*/ 189 h 500"/>
                <a:gd name="T24" fmla="*/ 360 w 2604"/>
                <a:gd name="T25" fmla="*/ 215 h 500"/>
                <a:gd name="T26" fmla="*/ 414 w 2604"/>
                <a:gd name="T27" fmla="*/ 215 h 500"/>
                <a:gd name="T28" fmla="*/ 428 w 2604"/>
                <a:gd name="T29" fmla="*/ 215 h 500"/>
                <a:gd name="T30" fmla="*/ 474 w 2604"/>
                <a:gd name="T31" fmla="*/ 215 h 500"/>
                <a:gd name="T32" fmla="*/ 531 w 2604"/>
                <a:gd name="T33" fmla="*/ 240 h 500"/>
                <a:gd name="T34" fmla="*/ 555 w 2604"/>
                <a:gd name="T35" fmla="*/ 240 h 500"/>
                <a:gd name="T36" fmla="*/ 609 w 2604"/>
                <a:gd name="T37" fmla="*/ 267 h 500"/>
                <a:gd name="T38" fmla="*/ 772 w 2604"/>
                <a:gd name="T39" fmla="*/ 267 h 500"/>
                <a:gd name="T40" fmla="*/ 783 w 2604"/>
                <a:gd name="T41" fmla="*/ 292 h 500"/>
                <a:gd name="T42" fmla="*/ 823 w 2604"/>
                <a:gd name="T43" fmla="*/ 319 h 500"/>
                <a:gd name="T44" fmla="*/ 920 w 2604"/>
                <a:gd name="T45" fmla="*/ 319 h 500"/>
                <a:gd name="T46" fmla="*/ 932 w 2604"/>
                <a:gd name="T47" fmla="*/ 346 h 500"/>
                <a:gd name="T48" fmla="*/ 964 w 2604"/>
                <a:gd name="T49" fmla="*/ 375 h 500"/>
                <a:gd name="T50" fmla="*/ 1053 w 2604"/>
                <a:gd name="T51" fmla="*/ 402 h 500"/>
                <a:gd name="T52" fmla="*/ 1070 w 2604"/>
                <a:gd name="T53" fmla="*/ 402 h 500"/>
                <a:gd name="T54" fmla="*/ 1083 w 2604"/>
                <a:gd name="T55" fmla="*/ 402 h 500"/>
                <a:gd name="T56" fmla="*/ 1134 w 2604"/>
                <a:gd name="T57" fmla="*/ 430 h 500"/>
                <a:gd name="T58" fmla="*/ 1172 w 2604"/>
                <a:gd name="T59" fmla="*/ 459 h 500"/>
                <a:gd name="T60" fmla="*/ 1207 w 2604"/>
                <a:gd name="T61" fmla="*/ 459 h 500"/>
                <a:gd name="T62" fmla="*/ 1221 w 2604"/>
                <a:gd name="T63" fmla="*/ 459 h 500"/>
                <a:gd name="T64" fmla="*/ 1475 w 2604"/>
                <a:gd name="T65" fmla="*/ 459 h 500"/>
                <a:gd name="T66" fmla="*/ 1562 w 2604"/>
                <a:gd name="T67" fmla="*/ 459 h 500"/>
                <a:gd name="T68" fmla="*/ 1628 w 2604"/>
                <a:gd name="T69" fmla="*/ 459 h 500"/>
                <a:gd name="T70" fmla="*/ 1654 w 2604"/>
                <a:gd name="T71" fmla="*/ 459 h 500"/>
                <a:gd name="T72" fmla="*/ 1801 w 2604"/>
                <a:gd name="T73" fmla="*/ 459 h 500"/>
                <a:gd name="T74" fmla="*/ 1992 w 2604"/>
                <a:gd name="T75" fmla="*/ 459 h 500"/>
                <a:gd name="T76" fmla="*/ 2014 w 2604"/>
                <a:gd name="T77" fmla="*/ 459 h 500"/>
                <a:gd name="T78" fmla="*/ 2110 w 2604"/>
                <a:gd name="T79" fmla="*/ 459 h 500"/>
                <a:gd name="T80" fmla="*/ 2166 w 2604"/>
                <a:gd name="T81" fmla="*/ 459 h 500"/>
                <a:gd name="T82" fmla="*/ 2169 w 2604"/>
                <a:gd name="T83" fmla="*/ 459 h 500"/>
                <a:gd name="T84" fmla="*/ 2264 w 2604"/>
                <a:gd name="T85" fmla="*/ 459 h 500"/>
                <a:gd name="T86" fmla="*/ 2293 w 2604"/>
                <a:gd name="T87" fmla="*/ 500 h 500"/>
                <a:gd name="T88" fmla="*/ 2445 w 2604"/>
                <a:gd name="T89" fmla="*/ 500 h 500"/>
                <a:gd name="T90" fmla="*/ 2488 w 2604"/>
                <a:gd name="T91" fmla="*/ 500 h 500"/>
                <a:gd name="T92" fmla="*/ 2604 w 2604"/>
                <a:gd name="T93" fmla="*/ 500 h 5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2604" h="500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1" y="0"/>
                  </a:lnTo>
                  <a:lnTo>
                    <a:pt x="1" y="23"/>
                  </a:lnTo>
                  <a:lnTo>
                    <a:pt x="1" y="23"/>
                  </a:lnTo>
                  <a:lnTo>
                    <a:pt x="33" y="23"/>
                  </a:lnTo>
                  <a:lnTo>
                    <a:pt x="33" y="23"/>
                  </a:lnTo>
                  <a:lnTo>
                    <a:pt x="33" y="23"/>
                  </a:lnTo>
                  <a:lnTo>
                    <a:pt x="57" y="23"/>
                  </a:lnTo>
                  <a:lnTo>
                    <a:pt x="57" y="46"/>
                  </a:lnTo>
                  <a:lnTo>
                    <a:pt x="57" y="46"/>
                  </a:lnTo>
                  <a:lnTo>
                    <a:pt x="81" y="46"/>
                  </a:lnTo>
                  <a:lnTo>
                    <a:pt x="81" y="70"/>
                  </a:lnTo>
                  <a:lnTo>
                    <a:pt x="81" y="70"/>
                  </a:lnTo>
                  <a:lnTo>
                    <a:pt x="82" y="70"/>
                  </a:lnTo>
                  <a:lnTo>
                    <a:pt x="82" y="94"/>
                  </a:lnTo>
                  <a:lnTo>
                    <a:pt x="82" y="94"/>
                  </a:lnTo>
                  <a:lnTo>
                    <a:pt x="114" y="94"/>
                  </a:lnTo>
                  <a:lnTo>
                    <a:pt x="114" y="118"/>
                  </a:lnTo>
                  <a:lnTo>
                    <a:pt x="114" y="118"/>
                  </a:lnTo>
                  <a:lnTo>
                    <a:pt x="144" y="118"/>
                  </a:lnTo>
                  <a:lnTo>
                    <a:pt x="144" y="142"/>
                  </a:lnTo>
                  <a:lnTo>
                    <a:pt x="144" y="142"/>
                  </a:lnTo>
                  <a:lnTo>
                    <a:pt x="168" y="142"/>
                  </a:lnTo>
                  <a:lnTo>
                    <a:pt x="168" y="142"/>
                  </a:lnTo>
                  <a:lnTo>
                    <a:pt x="168" y="142"/>
                  </a:lnTo>
                  <a:lnTo>
                    <a:pt x="182" y="142"/>
                  </a:lnTo>
                  <a:lnTo>
                    <a:pt x="182" y="165"/>
                  </a:lnTo>
                  <a:lnTo>
                    <a:pt x="182" y="165"/>
                  </a:lnTo>
                  <a:lnTo>
                    <a:pt x="208" y="165"/>
                  </a:lnTo>
                  <a:lnTo>
                    <a:pt x="208" y="189"/>
                  </a:lnTo>
                  <a:lnTo>
                    <a:pt x="208" y="189"/>
                  </a:lnTo>
                  <a:lnTo>
                    <a:pt x="342" y="189"/>
                  </a:lnTo>
                  <a:lnTo>
                    <a:pt x="342" y="189"/>
                  </a:lnTo>
                  <a:lnTo>
                    <a:pt x="342" y="189"/>
                  </a:lnTo>
                  <a:lnTo>
                    <a:pt x="360" y="189"/>
                  </a:lnTo>
                  <a:lnTo>
                    <a:pt x="360" y="215"/>
                  </a:lnTo>
                  <a:lnTo>
                    <a:pt x="360" y="215"/>
                  </a:lnTo>
                  <a:lnTo>
                    <a:pt x="414" y="215"/>
                  </a:lnTo>
                  <a:lnTo>
                    <a:pt x="414" y="215"/>
                  </a:lnTo>
                  <a:lnTo>
                    <a:pt x="414" y="215"/>
                  </a:lnTo>
                  <a:lnTo>
                    <a:pt x="428" y="215"/>
                  </a:lnTo>
                  <a:lnTo>
                    <a:pt x="428" y="215"/>
                  </a:lnTo>
                  <a:lnTo>
                    <a:pt x="428" y="215"/>
                  </a:lnTo>
                  <a:lnTo>
                    <a:pt x="474" y="215"/>
                  </a:lnTo>
                  <a:lnTo>
                    <a:pt x="474" y="215"/>
                  </a:lnTo>
                  <a:lnTo>
                    <a:pt x="474" y="215"/>
                  </a:lnTo>
                  <a:lnTo>
                    <a:pt x="531" y="215"/>
                  </a:lnTo>
                  <a:lnTo>
                    <a:pt x="531" y="240"/>
                  </a:lnTo>
                  <a:lnTo>
                    <a:pt x="531" y="240"/>
                  </a:lnTo>
                  <a:lnTo>
                    <a:pt x="555" y="240"/>
                  </a:lnTo>
                  <a:lnTo>
                    <a:pt x="555" y="240"/>
                  </a:lnTo>
                  <a:lnTo>
                    <a:pt x="555" y="240"/>
                  </a:lnTo>
                  <a:lnTo>
                    <a:pt x="609" y="240"/>
                  </a:lnTo>
                  <a:lnTo>
                    <a:pt x="609" y="267"/>
                  </a:lnTo>
                  <a:lnTo>
                    <a:pt x="609" y="267"/>
                  </a:lnTo>
                  <a:lnTo>
                    <a:pt x="772" y="267"/>
                  </a:lnTo>
                  <a:lnTo>
                    <a:pt x="772" y="267"/>
                  </a:lnTo>
                  <a:lnTo>
                    <a:pt x="772" y="267"/>
                  </a:lnTo>
                  <a:lnTo>
                    <a:pt x="783" y="267"/>
                  </a:lnTo>
                  <a:lnTo>
                    <a:pt x="783" y="292"/>
                  </a:lnTo>
                  <a:lnTo>
                    <a:pt x="783" y="292"/>
                  </a:lnTo>
                  <a:lnTo>
                    <a:pt x="823" y="292"/>
                  </a:lnTo>
                  <a:lnTo>
                    <a:pt x="823" y="319"/>
                  </a:lnTo>
                  <a:lnTo>
                    <a:pt x="823" y="319"/>
                  </a:lnTo>
                  <a:lnTo>
                    <a:pt x="920" y="319"/>
                  </a:lnTo>
                  <a:lnTo>
                    <a:pt x="920" y="319"/>
                  </a:lnTo>
                  <a:lnTo>
                    <a:pt x="920" y="319"/>
                  </a:lnTo>
                  <a:lnTo>
                    <a:pt x="932" y="319"/>
                  </a:lnTo>
                  <a:lnTo>
                    <a:pt x="932" y="346"/>
                  </a:lnTo>
                  <a:lnTo>
                    <a:pt x="940" y="346"/>
                  </a:lnTo>
                  <a:lnTo>
                    <a:pt x="964" y="346"/>
                  </a:lnTo>
                  <a:lnTo>
                    <a:pt x="964" y="375"/>
                  </a:lnTo>
                  <a:lnTo>
                    <a:pt x="964" y="375"/>
                  </a:lnTo>
                  <a:lnTo>
                    <a:pt x="1053" y="375"/>
                  </a:lnTo>
                  <a:lnTo>
                    <a:pt x="1053" y="402"/>
                  </a:lnTo>
                  <a:lnTo>
                    <a:pt x="1053" y="402"/>
                  </a:lnTo>
                  <a:lnTo>
                    <a:pt x="1070" y="402"/>
                  </a:lnTo>
                  <a:lnTo>
                    <a:pt x="1070" y="402"/>
                  </a:lnTo>
                  <a:lnTo>
                    <a:pt x="1070" y="402"/>
                  </a:lnTo>
                  <a:lnTo>
                    <a:pt x="1083" y="402"/>
                  </a:lnTo>
                  <a:lnTo>
                    <a:pt x="1083" y="402"/>
                  </a:lnTo>
                  <a:lnTo>
                    <a:pt x="1083" y="402"/>
                  </a:lnTo>
                  <a:lnTo>
                    <a:pt x="1134" y="402"/>
                  </a:lnTo>
                  <a:lnTo>
                    <a:pt x="1134" y="430"/>
                  </a:lnTo>
                  <a:lnTo>
                    <a:pt x="1134" y="430"/>
                  </a:lnTo>
                  <a:lnTo>
                    <a:pt x="1172" y="430"/>
                  </a:lnTo>
                  <a:lnTo>
                    <a:pt x="1172" y="459"/>
                  </a:lnTo>
                  <a:lnTo>
                    <a:pt x="1172" y="459"/>
                  </a:lnTo>
                  <a:lnTo>
                    <a:pt x="1207" y="459"/>
                  </a:lnTo>
                  <a:lnTo>
                    <a:pt x="1207" y="459"/>
                  </a:lnTo>
                  <a:lnTo>
                    <a:pt x="1207" y="459"/>
                  </a:lnTo>
                  <a:lnTo>
                    <a:pt x="1221" y="459"/>
                  </a:lnTo>
                  <a:lnTo>
                    <a:pt x="1221" y="459"/>
                  </a:lnTo>
                  <a:lnTo>
                    <a:pt x="1221" y="459"/>
                  </a:lnTo>
                  <a:lnTo>
                    <a:pt x="1475" y="459"/>
                  </a:lnTo>
                  <a:lnTo>
                    <a:pt x="1475" y="459"/>
                  </a:lnTo>
                  <a:lnTo>
                    <a:pt x="1475" y="459"/>
                  </a:lnTo>
                  <a:lnTo>
                    <a:pt x="1562" y="459"/>
                  </a:lnTo>
                  <a:lnTo>
                    <a:pt x="1562" y="459"/>
                  </a:lnTo>
                  <a:lnTo>
                    <a:pt x="1562" y="459"/>
                  </a:lnTo>
                  <a:lnTo>
                    <a:pt x="1628" y="459"/>
                  </a:lnTo>
                  <a:lnTo>
                    <a:pt x="1628" y="459"/>
                  </a:lnTo>
                  <a:lnTo>
                    <a:pt x="1628" y="459"/>
                  </a:lnTo>
                  <a:lnTo>
                    <a:pt x="1654" y="459"/>
                  </a:lnTo>
                  <a:lnTo>
                    <a:pt x="1654" y="459"/>
                  </a:lnTo>
                  <a:lnTo>
                    <a:pt x="1654" y="459"/>
                  </a:lnTo>
                  <a:lnTo>
                    <a:pt x="1801" y="459"/>
                  </a:lnTo>
                  <a:lnTo>
                    <a:pt x="1801" y="459"/>
                  </a:lnTo>
                  <a:lnTo>
                    <a:pt x="1801" y="459"/>
                  </a:lnTo>
                  <a:lnTo>
                    <a:pt x="1992" y="459"/>
                  </a:lnTo>
                  <a:lnTo>
                    <a:pt x="1992" y="459"/>
                  </a:lnTo>
                  <a:lnTo>
                    <a:pt x="1992" y="459"/>
                  </a:lnTo>
                  <a:lnTo>
                    <a:pt x="2014" y="459"/>
                  </a:lnTo>
                  <a:lnTo>
                    <a:pt x="2014" y="459"/>
                  </a:lnTo>
                  <a:lnTo>
                    <a:pt x="2014" y="459"/>
                  </a:lnTo>
                  <a:lnTo>
                    <a:pt x="2110" y="459"/>
                  </a:lnTo>
                  <a:lnTo>
                    <a:pt x="2110" y="459"/>
                  </a:lnTo>
                  <a:lnTo>
                    <a:pt x="2110" y="459"/>
                  </a:lnTo>
                  <a:lnTo>
                    <a:pt x="2166" y="459"/>
                  </a:lnTo>
                  <a:lnTo>
                    <a:pt x="2166" y="459"/>
                  </a:lnTo>
                  <a:lnTo>
                    <a:pt x="2166" y="459"/>
                  </a:lnTo>
                  <a:lnTo>
                    <a:pt x="2169" y="459"/>
                  </a:lnTo>
                  <a:lnTo>
                    <a:pt x="2169" y="459"/>
                  </a:lnTo>
                  <a:lnTo>
                    <a:pt x="2169" y="459"/>
                  </a:lnTo>
                  <a:lnTo>
                    <a:pt x="2264" y="459"/>
                  </a:lnTo>
                  <a:lnTo>
                    <a:pt x="2264" y="459"/>
                  </a:lnTo>
                  <a:lnTo>
                    <a:pt x="2264" y="459"/>
                  </a:lnTo>
                  <a:lnTo>
                    <a:pt x="2293" y="459"/>
                  </a:lnTo>
                  <a:lnTo>
                    <a:pt x="2293" y="500"/>
                  </a:lnTo>
                  <a:lnTo>
                    <a:pt x="2293" y="500"/>
                  </a:lnTo>
                  <a:lnTo>
                    <a:pt x="2445" y="500"/>
                  </a:lnTo>
                  <a:lnTo>
                    <a:pt x="2445" y="500"/>
                  </a:lnTo>
                  <a:lnTo>
                    <a:pt x="2445" y="500"/>
                  </a:lnTo>
                  <a:lnTo>
                    <a:pt x="2488" y="500"/>
                  </a:lnTo>
                  <a:lnTo>
                    <a:pt x="2488" y="500"/>
                  </a:lnTo>
                  <a:lnTo>
                    <a:pt x="2488" y="500"/>
                  </a:lnTo>
                  <a:lnTo>
                    <a:pt x="2604" y="500"/>
                  </a:lnTo>
                  <a:lnTo>
                    <a:pt x="2604" y="500"/>
                  </a:lnTo>
                </a:path>
              </a:pathLst>
            </a:custGeom>
            <a:noFill/>
            <a:ln w="4603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Rectangle 19">
              <a:extLst>
                <a:ext uri="{FF2B5EF4-FFF2-40B4-BE49-F238E27FC236}">
                  <a16:creationId xmlns:a16="http://schemas.microsoft.com/office/drawing/2014/main" id="{D8EAC6C9-441B-A24F-93E9-052C7FABEB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92" y="1450"/>
              <a:ext cx="1744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MS UI Gothic" panose="020B0600070205080204" pitchFamily="50" charset="-128"/>
                  <a:cs typeface="Times New Roman" panose="02020603050405020304" pitchFamily="18" charset="0"/>
                </a:rPr>
                <a:t>Hyperpolypharmacy </a:t>
              </a:r>
              <a:r>
                <a:rPr kumimoji="0" lang="ja-JP" altLang="ja-JP" sz="2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MS UI Gothic" panose="020B0600070205080204" pitchFamily="50" charset="-128"/>
                  <a:cs typeface="Times New Roman" panose="02020603050405020304" pitchFamily="18" charset="0"/>
                </a:rPr>
                <a:t>group</a:t>
              </a:r>
              <a:endParaRPr kumimoji="0" lang="ja-JP" altLang="ja-JP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21">
              <a:extLst>
                <a:ext uri="{FF2B5EF4-FFF2-40B4-BE49-F238E27FC236}">
                  <a16:creationId xmlns:a16="http://schemas.microsoft.com/office/drawing/2014/main" id="{D3838AE8-67DA-914A-BBE3-6E6882B24E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83" y="1698"/>
              <a:ext cx="2040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MS UI Gothic" panose="020B0600070205080204" pitchFamily="50" charset="-128"/>
                  <a:cs typeface="Times New Roman" panose="02020603050405020304" pitchFamily="18" charset="0"/>
                </a:rPr>
                <a:t>Non-hyperpolypharmacy group</a:t>
              </a:r>
              <a:endParaRPr kumimoji="0" lang="ja-JP" altLang="ja-JP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8" name="Rectangle 18">
            <a:extLst>
              <a:ext uri="{FF2B5EF4-FFF2-40B4-BE49-F238E27FC236}">
                <a16:creationId xmlns:a16="http://schemas.microsoft.com/office/drawing/2014/main" id="{9E9A142A-80AB-1F4D-BE65-3BE9E256CF8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46212" y="2822397"/>
            <a:ext cx="358950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 of event-free survival</a:t>
            </a:r>
            <a:endParaRPr lang="ja-JP" altLang="en-US" sz="2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17">
            <a:extLst>
              <a:ext uri="{FF2B5EF4-FFF2-40B4-BE49-F238E27FC236}">
                <a16:creationId xmlns:a16="http://schemas.microsoft.com/office/drawing/2014/main" id="{C06F1A95-A870-5349-A8FB-8B04490051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8595" y="4963910"/>
            <a:ext cx="1296644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UI Gothic" panose="020B0600070205080204" pitchFamily="50" charset="-128"/>
                <a:cs typeface="Times New Roman" panose="02020603050405020304" pitchFamily="18" charset="0"/>
              </a:rPr>
              <a:t>Time (</a:t>
            </a:r>
            <a:r>
              <a:rPr kumimoji="0" lang="ja-JP" altLang="ja-JP" sz="2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UI Gothic" panose="020B0600070205080204" pitchFamily="50" charset="-128"/>
                <a:cs typeface="Times New Roman" panose="02020603050405020304" pitchFamily="18" charset="0"/>
              </a:rPr>
              <a:t>days</a:t>
            </a:r>
            <a:r>
              <a:rPr kumimoji="0" lang="en-US" altLang="ja-JP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UI Gothic" panose="020B0600070205080204" pitchFamily="50" charset="-128"/>
                <a:cs typeface="Times New Roman" panose="02020603050405020304" pitchFamily="18" charset="0"/>
              </a:rPr>
              <a:t>)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E0B85CFA-08E8-1B44-8C63-40B67ECE0984}"/>
              </a:ext>
            </a:extLst>
          </p:cNvPr>
          <p:cNvSpPr/>
          <p:nvPr/>
        </p:nvSpPr>
        <p:spPr>
          <a:xfrm>
            <a:off x="4669483" y="3255834"/>
            <a:ext cx="271901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g-rank, </a:t>
            </a:r>
            <a:r>
              <a:rPr lang="en-US" altLang="ja-JP" sz="24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2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0.30</a:t>
            </a:r>
            <a:endParaRPr lang="ja-JP" altLang="en-US" sz="2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D6747F0E-6D04-2248-BB19-A018450EDCC2}"/>
              </a:ext>
            </a:extLst>
          </p:cNvPr>
          <p:cNvCxnSpPr>
            <a:cxnSpLocks/>
          </p:cNvCxnSpPr>
          <p:nvPr/>
        </p:nvCxnSpPr>
        <p:spPr>
          <a:xfrm>
            <a:off x="10864665" y="1706008"/>
            <a:ext cx="383708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C2636A6C-0FBA-AB48-8AD2-01A53BC22646}"/>
              </a:ext>
            </a:extLst>
          </p:cNvPr>
          <p:cNvCxnSpPr>
            <a:cxnSpLocks/>
          </p:cNvCxnSpPr>
          <p:nvPr/>
        </p:nvCxnSpPr>
        <p:spPr>
          <a:xfrm>
            <a:off x="10864665" y="2122210"/>
            <a:ext cx="383708" cy="0"/>
          </a:xfrm>
          <a:prstGeom prst="line">
            <a:avLst/>
          </a:prstGeom>
          <a:ln w="38100">
            <a:solidFill>
              <a:srgbClr val="0033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00ADDBA6-23A7-3342-997F-F56D695654C2}"/>
              </a:ext>
            </a:extLst>
          </p:cNvPr>
          <p:cNvSpPr/>
          <p:nvPr/>
        </p:nvSpPr>
        <p:spPr>
          <a:xfrm>
            <a:off x="3345908" y="1170140"/>
            <a:ext cx="575578" cy="5358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FD43D27-4FA4-4A56-9BF8-A40107C56A6C}"/>
              </a:ext>
            </a:extLst>
          </p:cNvPr>
          <p:cNvSpPr txBox="1"/>
          <p:nvPr/>
        </p:nvSpPr>
        <p:spPr>
          <a:xfrm>
            <a:off x="73413" y="0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29536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コンテンツ プレースホルダー 4">
            <a:extLst>
              <a:ext uri="{FF2B5EF4-FFF2-40B4-BE49-F238E27FC236}">
                <a16:creationId xmlns:a16="http://schemas.microsoft.com/office/drawing/2014/main" id="{95734661-1243-7344-BBBC-FD08F1229D1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145591"/>
            <a:ext cx="7425999" cy="4351338"/>
          </a:xfr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90EFD7B1-1148-6149-9020-546364D2CEB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84"/>
          <a:stretch/>
        </p:blipFill>
        <p:spPr>
          <a:xfrm>
            <a:off x="6945237" y="2077274"/>
            <a:ext cx="4889326" cy="4487971"/>
          </a:xfrm>
          <a:prstGeom prst="rect">
            <a:avLst/>
          </a:prstGeom>
        </p:spPr>
      </p:pic>
      <p:sp>
        <p:nvSpPr>
          <p:cNvPr id="8" name="Rectangle 19">
            <a:extLst>
              <a:ext uri="{FF2B5EF4-FFF2-40B4-BE49-F238E27FC236}">
                <a16:creationId xmlns:a16="http://schemas.microsoft.com/office/drawing/2014/main" id="{97968685-4114-1E4D-BB9B-AAC581B745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3254" y="1603486"/>
            <a:ext cx="490198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ja-JP" altLang="ja-JP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2400" b="1" i="0" u="none" strike="noStrike" kern="0" cap="none" normalizeH="0" baseline="0" dirty="0">
                <a:ln>
                  <a:noFill/>
                </a:ln>
                <a:solidFill>
                  <a:srgbClr val="141413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M</a:t>
            </a:r>
            <a:r>
              <a:rPr lang="en-US" altLang="ja-JP" sz="2400" b="1" kern="0" dirty="0">
                <a:solidFill>
                  <a:srgbClr val="141413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ajor adverse cardiovascular events</a:t>
            </a:r>
            <a:endParaRPr kumimoji="0" lang="ja-JP" altLang="ja-JP" sz="2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19">
            <a:extLst>
              <a:ext uri="{FF2B5EF4-FFF2-40B4-BE49-F238E27FC236}">
                <a16:creationId xmlns:a16="http://schemas.microsoft.com/office/drawing/2014/main" id="{F61156CD-73AC-6842-87B4-FA9C9BAAF1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64215" y="1480375"/>
            <a:ext cx="2622513" cy="4924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3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ja-JP" altLang="ja-JP" sz="2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l-cause mortality</a:t>
            </a:r>
            <a:endParaRPr kumimoji="0" lang="ja-JP" altLang="ja-JP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E7744E2-D291-AE48-9B97-0F510E768D53}"/>
              </a:ext>
            </a:extLst>
          </p:cNvPr>
          <p:cNvSpPr txBox="1"/>
          <p:nvPr/>
        </p:nvSpPr>
        <p:spPr>
          <a:xfrm>
            <a:off x="5856718" y="855688"/>
            <a:ext cx="54322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atients who were taking</a:t>
            </a:r>
            <a:r>
              <a:rPr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al antithrombotic agent (antiplatelet agent and anticoagulant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4346311-86AD-C346-979A-1DE2723C30E3}"/>
              </a:ext>
            </a:extLst>
          </p:cNvPr>
          <p:cNvSpPr txBox="1"/>
          <p:nvPr/>
        </p:nvSpPr>
        <p:spPr>
          <a:xfrm>
            <a:off x="7649237" y="1080515"/>
            <a:ext cx="35094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atients who were not taking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y antithrombotic agent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Line 48">
            <a:extLst>
              <a:ext uri="{FF2B5EF4-FFF2-40B4-BE49-F238E27FC236}">
                <a16:creationId xmlns:a16="http://schemas.microsoft.com/office/drawing/2014/main" id="{1DDCE2F7-CF5E-7742-8D9E-BA17F9C8ECFF}"/>
              </a:ext>
            </a:extLst>
          </p:cNvPr>
          <p:cNvSpPr>
            <a:spLocks noChangeShapeType="1"/>
          </p:cNvSpPr>
          <p:nvPr/>
        </p:nvSpPr>
        <p:spPr bwMode="auto">
          <a:xfrm>
            <a:off x="11288995" y="978066"/>
            <a:ext cx="352002" cy="0"/>
          </a:xfrm>
          <a:prstGeom prst="line">
            <a:avLst/>
          </a:prstGeom>
          <a:noFill/>
          <a:ln w="61913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Line 45">
            <a:extLst>
              <a:ext uri="{FF2B5EF4-FFF2-40B4-BE49-F238E27FC236}">
                <a16:creationId xmlns:a16="http://schemas.microsoft.com/office/drawing/2014/main" id="{00C9A0DA-9363-C742-91CF-11BEA4975B2F}"/>
              </a:ext>
            </a:extLst>
          </p:cNvPr>
          <p:cNvSpPr>
            <a:spLocks noChangeShapeType="1"/>
          </p:cNvSpPr>
          <p:nvPr/>
        </p:nvSpPr>
        <p:spPr bwMode="auto">
          <a:xfrm>
            <a:off x="11288995" y="1213944"/>
            <a:ext cx="352002" cy="0"/>
          </a:xfrm>
          <a:prstGeom prst="line">
            <a:avLst/>
          </a:prstGeom>
          <a:noFill/>
          <a:ln w="61913" cap="flat">
            <a:solidFill>
              <a:srgbClr val="0000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B6420B5-EE86-4E0F-B95E-F9B4B5E2C56F}"/>
              </a:ext>
            </a:extLst>
          </p:cNvPr>
          <p:cNvSpPr txBox="1"/>
          <p:nvPr/>
        </p:nvSpPr>
        <p:spPr>
          <a:xfrm>
            <a:off x="49788" y="5833481"/>
            <a:ext cx="2197756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ients who were taking</a:t>
            </a:r>
            <a:r>
              <a:rPr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al antithrombotic agent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0256F45C-56F2-46B9-8455-A93E6C6F0F26}"/>
              </a:ext>
            </a:extLst>
          </p:cNvPr>
          <p:cNvSpPr/>
          <p:nvPr/>
        </p:nvSpPr>
        <p:spPr>
          <a:xfrm>
            <a:off x="49788" y="6221723"/>
            <a:ext cx="2334488" cy="43088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ho were not taking any antithrombotic agent</a:t>
            </a:r>
            <a:endParaRPr lang="ja-JP" altLang="en-US" sz="11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CE83F3C-0126-4721-9E29-6E54C843D4EA}"/>
              </a:ext>
            </a:extLst>
          </p:cNvPr>
          <p:cNvSpPr txBox="1"/>
          <p:nvPr/>
        </p:nvSpPr>
        <p:spPr>
          <a:xfrm>
            <a:off x="73413" y="0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4376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7</TotalTime>
  <Words>104</Words>
  <Application>Microsoft Office PowerPoint</Application>
  <PresentationFormat>ワイド画面</PresentationFormat>
  <Paragraphs>28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ＭＳ Ｐゴシック</vt:lpstr>
      <vt:lpstr>MS UI Gothic</vt:lpstr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hkondo</cp:lastModifiedBy>
  <cp:revision>13</cp:revision>
  <dcterms:created xsi:type="dcterms:W3CDTF">2024-09-29T09:38:23Z</dcterms:created>
  <dcterms:modified xsi:type="dcterms:W3CDTF">2024-09-30T12:39:33Z</dcterms:modified>
</cp:coreProperties>
</file>